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5" autoAdjust="0"/>
    <p:restoredTop sz="94660"/>
  </p:normalViewPr>
  <p:slideViewPr>
    <p:cSldViewPr snapToGrid="0">
      <p:cViewPr varScale="1">
        <p:scale>
          <a:sx n="74" d="100"/>
          <a:sy n="74" d="100"/>
        </p:scale>
        <p:origin x="1206" y="72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447AD6-E122-425C-B66A-4A22416DE9FF}" type="datetimeFigureOut">
              <a:rPr lang="de-DE" smtClean="0"/>
              <a:t>09.01.20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3D8766-D8FC-4918-B125-D9E44343E66D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712187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447AD6-E122-425C-B66A-4A22416DE9FF}" type="datetimeFigureOut">
              <a:rPr lang="de-DE" smtClean="0"/>
              <a:t>09.01.20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3D8766-D8FC-4918-B125-D9E44343E66D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881048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447AD6-E122-425C-B66A-4A22416DE9FF}" type="datetimeFigureOut">
              <a:rPr lang="de-DE" smtClean="0"/>
              <a:t>09.01.20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3D8766-D8FC-4918-B125-D9E44343E66D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999294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447AD6-E122-425C-B66A-4A22416DE9FF}" type="datetimeFigureOut">
              <a:rPr lang="de-DE" smtClean="0"/>
              <a:t>09.01.20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3D8766-D8FC-4918-B125-D9E44343E66D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783303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447AD6-E122-425C-B66A-4A22416DE9FF}" type="datetimeFigureOut">
              <a:rPr lang="de-DE" smtClean="0"/>
              <a:t>09.01.20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3D8766-D8FC-4918-B125-D9E44343E66D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649113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447AD6-E122-425C-B66A-4A22416DE9FF}" type="datetimeFigureOut">
              <a:rPr lang="de-DE" smtClean="0"/>
              <a:t>09.01.2019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3D8766-D8FC-4918-B125-D9E44343E66D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406104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447AD6-E122-425C-B66A-4A22416DE9FF}" type="datetimeFigureOut">
              <a:rPr lang="de-DE" smtClean="0"/>
              <a:t>09.01.2019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3D8766-D8FC-4918-B125-D9E44343E66D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078215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447AD6-E122-425C-B66A-4A22416DE9FF}" type="datetimeFigureOut">
              <a:rPr lang="de-DE" smtClean="0"/>
              <a:t>09.01.2019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3D8766-D8FC-4918-B125-D9E44343E66D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559381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447AD6-E122-425C-B66A-4A22416DE9FF}" type="datetimeFigureOut">
              <a:rPr lang="de-DE" smtClean="0"/>
              <a:t>09.01.2019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3D8766-D8FC-4918-B125-D9E44343E66D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930951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447AD6-E122-425C-B66A-4A22416DE9FF}" type="datetimeFigureOut">
              <a:rPr lang="de-DE" smtClean="0"/>
              <a:t>09.01.2019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3D8766-D8FC-4918-B125-D9E44343E66D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583798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447AD6-E122-425C-B66A-4A22416DE9FF}" type="datetimeFigureOut">
              <a:rPr lang="de-DE" smtClean="0"/>
              <a:t>09.01.2019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3D8766-D8FC-4918-B125-D9E44343E66D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034823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447AD6-E122-425C-B66A-4A22416DE9FF}" type="datetimeFigureOut">
              <a:rPr lang="de-DE" smtClean="0"/>
              <a:t>09.01.20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3D8766-D8FC-4918-B125-D9E44343E66D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443944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5634" y="174343"/>
            <a:ext cx="8841838" cy="5716705"/>
          </a:xfrm>
          <a:prstGeom prst="rect">
            <a:avLst/>
          </a:prstGeom>
        </p:spPr>
      </p:pic>
      <p:sp>
        <p:nvSpPr>
          <p:cNvPr id="29" name="Rechteck 1"/>
          <p:cNvSpPr/>
          <p:nvPr/>
        </p:nvSpPr>
        <p:spPr>
          <a:xfrm>
            <a:off x="145634" y="5891048"/>
            <a:ext cx="8841838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dditional </a:t>
            </a:r>
            <a:r>
              <a:rPr lang="en-US" sz="1200" b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le </a:t>
            </a:r>
            <a:r>
              <a:rPr lang="en-US" sz="1200" b="1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4.</a:t>
            </a:r>
            <a:r>
              <a:rPr lang="en-US" sz="120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ylogenetic tree of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-10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s and summary of the expression profile of the 21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-10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soforms in untreated leaves, stems and roots of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vitro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ultivated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. ×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anass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lants (green bars) and infected tissues with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V.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ahliae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red bars) at various time points (days) post pathogen inoculation (dpi). qPCR using specific primers for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-10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s and the reference gene was used for the expression analysis.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022033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82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hahca</dc:creator>
  <cp:lastModifiedBy>mhahca</cp:lastModifiedBy>
  <cp:revision>19</cp:revision>
  <dcterms:created xsi:type="dcterms:W3CDTF">2018-05-30T12:15:51Z</dcterms:created>
  <dcterms:modified xsi:type="dcterms:W3CDTF">2019-01-09T14:05:51Z</dcterms:modified>
</cp:coreProperties>
</file>